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9CDAA-817B-44EC-B7E1-7A10979991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CD0AA-EBB9-479F-B4E7-700B220D1E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4815C-D07B-4F41-BA9F-331E253363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9FAD3-DF62-4E13-BA60-4D5E67695D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70C58-1237-40A6-8E74-8AC88C150F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C0E50-826D-401C-AB49-5E6645F09F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24F5B-4E2A-49F4-978D-B4F82D2C30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52AA5-C5B3-4770-910E-2FEC7E82D6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BF050-33EB-41DD-890E-D3CB1D46BA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E644A-11A0-4176-8D6C-BCC609A72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E2FEE-948A-419E-93A7-945B0E718B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1932E-E754-4EDB-932A-F1D88211E8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B8B089-5BE7-47EE-8574-5723EAE4A80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835280" y="1922400"/>
          <a:ext cx="5618160" cy="3149640"/>
        </p:xfrm>
        <a:graphic>
          <a:graphicData uri="http://schemas.openxmlformats.org/drawingml/2006/table">
            <a:tbl>
              <a:tblPr/>
              <a:tblGrid>
                <a:gridCol w="1363680"/>
                <a:gridCol w="1290600"/>
                <a:gridCol w="1400040"/>
                <a:gridCol w="811080"/>
                <a:gridCol w="752760"/>
              </a:tblGrid>
              <a:tr h="189000"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u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900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famil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expres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NA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 rowSpan="7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B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C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9C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rowSpan="5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10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10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10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10-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H10-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86"/>
          <p:cNvSpPr/>
          <p:nvPr/>
        </p:nvSpPr>
        <p:spPr>
          <a:xfrm>
            <a:off x="1782720" y="1556640"/>
            <a:ext cx="386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able S1 Counts for the transgenetic lines in ri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29T05:07:36Z</dcterms:created>
  <dc:creator>微软中国</dc:creator>
  <dc:description/>
  <dc:language>en-US</dc:language>
  <cp:lastModifiedBy>0011692</cp:lastModifiedBy>
  <dcterms:modified xsi:type="dcterms:W3CDTF">2017-11-28T10:30:59Z</dcterms:modified>
  <cp:revision>2</cp:revision>
  <dc:subject/>
  <dc:title>幻灯片 1</dc:title>
</cp:coreProperties>
</file>